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61" r:id="rId2"/>
    <p:sldId id="26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A0AAA"/>
    <a:srgbClr val="FFFFFF"/>
    <a:srgbClr val="FF9900"/>
    <a:srgbClr val="FFFFEB"/>
    <a:srgbClr val="ECC39A"/>
    <a:srgbClr val="FFCC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033" autoAdjust="0"/>
  </p:normalViewPr>
  <p:slideViewPr>
    <p:cSldViewPr snapToGrid="0">
      <p:cViewPr>
        <p:scale>
          <a:sx n="96" d="100"/>
          <a:sy n="96" d="100"/>
        </p:scale>
        <p:origin x="1428" y="-1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234C27-8033-4087-9B51-BD0F2E725171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707AE1-4184-487C-ABFD-0E7D755E239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62771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832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4299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073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4137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9351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9024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841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176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09665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17336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0962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AA03ADC-E7C4-450C-B70F-CDBA5CD18BD5}" type="datetimeFigureOut">
              <a:rPr lang="it-IT" smtClean="0"/>
              <a:t>23/02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B4DF561-0B68-4BDC-B4C1-E42A86938D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85567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5">
            <a:extLst>
              <a:ext uri="{FF2B5EF4-FFF2-40B4-BE49-F238E27FC236}">
                <a16:creationId xmlns:a16="http://schemas.microsoft.com/office/drawing/2014/main" id="{49C7ABF8-F1E5-93AB-0DC3-EE5FE44546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662" y="6077154"/>
            <a:ext cx="6383338" cy="24720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kumimoji="0" lang="it-IT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Figure </a:t>
            </a:r>
            <a:r>
              <a:rPr lang="it-IT" alt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. </a:t>
            </a:r>
            <a:r>
              <a:rPr lang="en-US" alt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trinuclear </a:t>
            </a:r>
            <a:r>
              <a:rPr lang="en-US" sz="1000" b="1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u</a:t>
            </a:r>
            <a:r>
              <a:rPr lang="en-US" sz="1000" b="1" kern="1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+</a:t>
            </a:r>
            <a:r>
              <a:rPr lang="en-US" alt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altLang="en-US" sz="10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entre</a:t>
            </a:r>
            <a:r>
              <a:rPr lang="en-US" altLang="en-US" sz="10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C</a:t>
            </a:r>
            <a:r>
              <a:rPr lang="en-US" altLang="en-US" sz="10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, </a:t>
            </a:r>
            <a:r>
              <a:rPr lang="en-US" altLang="en-US" sz="1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ith 8 histidine residues coordinating of type II and type III </a:t>
            </a:r>
            <a:r>
              <a:rPr lang="en-US" sz="1000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u</a:t>
            </a:r>
            <a:r>
              <a:rPr lang="en-US" sz="1000" kern="1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+</a:t>
            </a:r>
            <a:r>
              <a:rPr lang="en-US" altLang="en-US" sz="1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ions. CP residues impacted by the </a:t>
            </a:r>
            <a:r>
              <a:rPr lang="en-US" altLang="en-US" sz="10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nomAD</a:t>
            </a:r>
            <a:r>
              <a:rPr lang="en-US" altLang="en-US" sz="1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variants p.H999Q (rs147475926, no </a:t>
            </a:r>
            <a:r>
              <a:rPr lang="en-US" altLang="en-US" sz="10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linvar</a:t>
            </a:r>
            <a:r>
              <a:rPr lang="en-US" altLang="en-US" sz="1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notation) and p.H180N (rs1180157664, no </a:t>
            </a:r>
            <a:r>
              <a:rPr lang="en-US" altLang="en-US" sz="10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linvar</a:t>
            </a:r>
            <a:r>
              <a:rPr lang="en-US" altLang="en-US" sz="1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notation) within the trinuclear </a:t>
            </a:r>
            <a:r>
              <a:rPr lang="en-US" sz="1000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u</a:t>
            </a:r>
            <a:r>
              <a:rPr lang="en-US" sz="1000" kern="1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+</a:t>
            </a:r>
            <a:r>
              <a:rPr lang="en-US" altLang="en-US" sz="1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luster (type II and type III </a:t>
            </a:r>
            <a:r>
              <a:rPr lang="en-US" sz="1000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u</a:t>
            </a:r>
            <a:r>
              <a:rPr lang="en-US" sz="1000" kern="1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+</a:t>
            </a:r>
            <a:r>
              <a:rPr lang="en-US" altLang="en-US" sz="1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, and the p.H997Q ACP mutation (See Table I; not present in </a:t>
            </a:r>
            <a:r>
              <a:rPr lang="en-US" altLang="en-US" sz="10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nomAD</a:t>
            </a:r>
            <a:r>
              <a:rPr lang="en-US" altLang="en-US" sz="1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are indicated. </a:t>
            </a:r>
            <a:r>
              <a:rPr lang="it-IT" altLang="en-US" sz="1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0" lang="it-IT" altLang="en-US" sz="10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endParaRPr kumimoji="0" lang="en-US" altLang="en-US" sz="1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F9B51946-D0FB-1D4B-B9C7-D3F7CA7761E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14136" r="12980" b="14075"/>
          <a:stretch/>
        </p:blipFill>
        <p:spPr>
          <a:xfrm>
            <a:off x="1401202" y="2230084"/>
            <a:ext cx="3920737" cy="35477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26880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>
            <a:extLst>
              <a:ext uri="{FF2B5EF4-FFF2-40B4-BE49-F238E27FC236}">
                <a16:creationId xmlns:a16="http://schemas.microsoft.com/office/drawing/2014/main" id="{12DC4608-2816-A358-3DEB-3E1F6E5025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2958" y="964883"/>
            <a:ext cx="166687" cy="415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en-US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Text Box 3">
            <a:extLst>
              <a:ext uri="{FF2B5EF4-FFF2-40B4-BE49-F238E27FC236}">
                <a16:creationId xmlns:a16="http://schemas.microsoft.com/office/drawing/2014/main" id="{240B5605-0B17-A9D6-1D60-BFC2243F12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01720" y="964883"/>
            <a:ext cx="168275" cy="415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en-US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Text Box 4">
            <a:extLst>
              <a:ext uri="{FF2B5EF4-FFF2-40B4-BE49-F238E27FC236}">
                <a16:creationId xmlns:a16="http://schemas.microsoft.com/office/drawing/2014/main" id="{78264015-96D3-E008-74CC-376DAD9814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9170" y="964883"/>
            <a:ext cx="168275" cy="415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en-US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b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Text Box 5">
            <a:extLst>
              <a:ext uri="{FF2B5EF4-FFF2-40B4-BE49-F238E27FC236}">
                <a16:creationId xmlns:a16="http://schemas.microsoft.com/office/drawing/2014/main" id="{49C7ABF8-F1E5-93AB-0DC3-EE5FE44546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2732" y="6976744"/>
            <a:ext cx="6383338" cy="24720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2.  Immunoblot analysis to illustrate behaviour of commercial anti-CP antibodies on various CP preparations . 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mmunoblot using as primary antibody the anti-serum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ptilite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1:2000; </a:t>
            </a:r>
            <a:r>
              <a:rPr kumimoji="0" lang="en-GB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,e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, polyclonal anti-CP epitope 20-259 (PA5-95336, 1:1000; </a:t>
            </a:r>
            <a:r>
              <a:rPr kumimoji="0" lang="en-GB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,f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, monoclonal anti-CP epitope 366-572 (MA5-38035, 1:2000; </a:t>
            </a:r>
            <a:r>
              <a:rPr kumimoji="0" lang="en-GB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,g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, and polyclonal anti-CP (Ab48614, 1:2000; </a:t>
            </a:r>
            <a:r>
              <a:rPr kumimoji="0" lang="en-GB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,h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in fully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naturating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non-reducing SDS-PAGE (</a:t>
            </a:r>
            <a:r>
              <a:rPr kumimoji="0" lang="en-GB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,b,c,d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or partially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naturating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non-reducing SDS-PAGE (</a:t>
            </a:r>
            <a:r>
              <a:rPr kumimoji="0" lang="en-GB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,f,g,h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on 4-12% Bis-Tris gels to reveal heterogeneity present in human ceruloplasmin preparations due to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oteoliytic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leavage (</a:t>
            </a:r>
            <a:r>
              <a:rPr kumimoji="0" lang="en-GB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,b,c,d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or the presence of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poceruloplasmin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Apo-CP) and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oloceruloplasmin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Holo-CP), and CP aggregates (</a:t>
            </a:r>
            <a:r>
              <a:rPr kumimoji="0" lang="en-GB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,f,g,h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. Loaded samples: A, lysate WT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CP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; B, human plasma-derived CP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edrion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dCP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K); C, commercial human plasma-derived CP  research-grade purified (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dCP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E); D, standard from Cp Colorimetric Activity Kit; E,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rnatant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T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CP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; F,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rnatant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T(-)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CP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HEK293T cells were transfected with WT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CP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media were supplemented with or without (WT(-) negative control) </a:t>
            </a:r>
            <a:r>
              <a:rPr kumimoji="0" lang="en-GB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uSO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₄·5H₂O. 48h post-transfection, cell lysates and supernatants were collected, and CP antigen levels were determined by the turbidimeter assay. In </a:t>
            </a:r>
            <a:r>
              <a:rPr kumimoji="0" lang="en-GB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,b,c,d</a:t>
            </a:r>
            <a:r>
              <a:rPr kumimoji="0" lang="en-GB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0 ng of CP were loaded for A, while 150ng of CP were loaded for B,C, and D. In </a:t>
            </a:r>
            <a:r>
              <a:rPr kumimoji="0" lang="en-GB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,f,g,h</a:t>
            </a:r>
            <a:r>
              <a:rPr kumimoji="0" lang="en-GB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0" lang="en-GB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ng of CP were loaded in each well. </a:t>
            </a: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6150" name="Picture 6">
            <a:extLst>
              <a:ext uri="{FF2B5EF4-FFF2-40B4-BE49-F238E27FC236}">
                <a16:creationId xmlns:a16="http://schemas.microsoft.com/office/drawing/2014/main" id="{FFE0ACFC-9EB7-13A7-38CA-A2196881EA7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045"/>
          <a:stretch>
            <a:fillRect/>
          </a:stretch>
        </p:blipFill>
        <p:spPr bwMode="auto">
          <a:xfrm>
            <a:off x="671195" y="1290320"/>
            <a:ext cx="5627688" cy="2136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pic>
      <p:pic>
        <p:nvPicPr>
          <p:cNvPr id="6151" name="Picture 7">
            <a:extLst>
              <a:ext uri="{FF2B5EF4-FFF2-40B4-BE49-F238E27FC236}">
                <a16:creationId xmlns:a16="http://schemas.microsoft.com/office/drawing/2014/main" id="{9CE19C10-AD69-27B2-654D-32523682455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6108" y="4028758"/>
            <a:ext cx="5730875" cy="22240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pic>
      <p:sp>
        <p:nvSpPr>
          <p:cNvPr id="6" name="Text Box 8">
            <a:extLst>
              <a:ext uri="{FF2B5EF4-FFF2-40B4-BE49-F238E27FC236}">
                <a16:creationId xmlns:a16="http://schemas.microsoft.com/office/drawing/2014/main" id="{82FBE67E-04A5-6CEE-1760-CD30EACE3A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97145" y="964883"/>
            <a:ext cx="168275" cy="415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en-US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d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Text Box 9">
            <a:extLst>
              <a:ext uri="{FF2B5EF4-FFF2-40B4-BE49-F238E27FC236}">
                <a16:creationId xmlns:a16="http://schemas.microsoft.com/office/drawing/2014/main" id="{5F400DB1-AC87-9703-B5C8-35EDDC9A4A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2958" y="3676333"/>
            <a:ext cx="166687" cy="415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en-US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e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Text Box 10">
            <a:extLst>
              <a:ext uri="{FF2B5EF4-FFF2-40B4-BE49-F238E27FC236}">
                <a16:creationId xmlns:a16="http://schemas.microsoft.com/office/drawing/2014/main" id="{AE5B0C44-FF6B-6143-9F82-CB5E9EEBC4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9170" y="3676333"/>
            <a:ext cx="168275" cy="415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en-US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Text Box 11">
            <a:extLst>
              <a:ext uri="{FF2B5EF4-FFF2-40B4-BE49-F238E27FC236}">
                <a16:creationId xmlns:a16="http://schemas.microsoft.com/office/drawing/2014/main" id="{5BB6730C-953A-526F-1989-1491BEB8C8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01720" y="3708083"/>
            <a:ext cx="168275" cy="415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en-US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g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Text Box 12">
            <a:extLst>
              <a:ext uri="{FF2B5EF4-FFF2-40B4-BE49-F238E27FC236}">
                <a16:creationId xmlns:a16="http://schemas.microsoft.com/office/drawing/2014/main" id="{B16D4B13-BB2C-9D54-4F9B-1FE6F1CA38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09845" y="3676333"/>
            <a:ext cx="168275" cy="415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en-US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h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Rectangle 13">
            <a:extLst>
              <a:ext uri="{FF2B5EF4-FFF2-40B4-BE49-F238E27FC236}">
                <a16:creationId xmlns:a16="http://schemas.microsoft.com/office/drawing/2014/main" id="{1791BB97-12E4-CB5A-9E70-00876A3B3B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6245" y="583883"/>
            <a:ext cx="6038850" cy="2930525"/>
          </a:xfrm>
          <a:prstGeom prst="rect">
            <a:avLst/>
          </a:prstGeom>
          <a:noFill/>
          <a:ln w="25400" algn="ctr">
            <a:solidFill>
              <a:srgbClr val="EBD7E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2" name="Rectangle 14">
            <a:extLst>
              <a:ext uri="{FF2B5EF4-FFF2-40B4-BE49-F238E27FC236}">
                <a16:creationId xmlns:a16="http://schemas.microsoft.com/office/drawing/2014/main" id="{1955E08C-9556-29A4-FADF-32BD7D002C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6245" y="3641408"/>
            <a:ext cx="6038850" cy="3063875"/>
          </a:xfrm>
          <a:prstGeom prst="rect">
            <a:avLst/>
          </a:prstGeom>
          <a:noFill/>
          <a:ln w="25400" algn="ctr">
            <a:solidFill>
              <a:srgbClr val="CEDDEA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3" name="Rectangle 15">
            <a:extLst>
              <a:ext uri="{FF2B5EF4-FFF2-40B4-BE49-F238E27FC236}">
                <a16:creationId xmlns:a16="http://schemas.microsoft.com/office/drawing/2014/main" id="{D3E8DBC3-EDFF-C902-4F26-B46B1990CB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6108" y="999808"/>
            <a:ext cx="1420812" cy="5314950"/>
          </a:xfrm>
          <a:prstGeom prst="rect">
            <a:avLst/>
          </a:prstGeom>
          <a:noFill/>
          <a:ln w="25400" algn="ctr">
            <a:solidFill>
              <a:srgbClr val="FFC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4" name="Rectangle 16">
            <a:extLst>
              <a:ext uri="{FF2B5EF4-FFF2-40B4-BE49-F238E27FC236}">
                <a16:creationId xmlns:a16="http://schemas.microsoft.com/office/drawing/2014/main" id="{A6EBA02F-3D9A-33A0-4A77-8640CA9308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3595" y="999808"/>
            <a:ext cx="1371600" cy="5314950"/>
          </a:xfrm>
          <a:prstGeom prst="rect">
            <a:avLst/>
          </a:prstGeom>
          <a:noFill/>
          <a:ln w="25400" algn="ctr">
            <a:solidFill>
              <a:srgbClr val="ED7D3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5" name="Rectangle 17">
            <a:extLst>
              <a:ext uri="{FF2B5EF4-FFF2-40B4-BE49-F238E27FC236}">
                <a16:creationId xmlns:a16="http://schemas.microsoft.com/office/drawing/2014/main" id="{E0F78118-6451-0D85-65F9-36830F91D3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22345" y="1009333"/>
            <a:ext cx="1371600" cy="5314950"/>
          </a:xfrm>
          <a:prstGeom prst="rect">
            <a:avLst/>
          </a:prstGeom>
          <a:noFill/>
          <a:ln w="25400" algn="ctr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6" name="Rectangle 18">
            <a:extLst>
              <a:ext uri="{FF2B5EF4-FFF2-40B4-BE49-F238E27FC236}">
                <a16:creationId xmlns:a16="http://schemas.microsoft.com/office/drawing/2014/main" id="{44D4EBFC-14D7-9C85-3FAB-FADCA3D05E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70145" y="1009333"/>
            <a:ext cx="1371600" cy="5314950"/>
          </a:xfrm>
          <a:prstGeom prst="rect">
            <a:avLst/>
          </a:prstGeom>
          <a:noFill/>
          <a:ln w="25400" algn="ctr">
            <a:solidFill>
              <a:srgbClr val="085296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17" name="Text Box 19">
            <a:extLst>
              <a:ext uri="{FF2B5EF4-FFF2-40B4-BE49-F238E27FC236}">
                <a16:creationId xmlns:a16="http://schemas.microsoft.com/office/drawing/2014/main" id="{09AD78A8-60C6-430B-E68C-2D84EE273A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2058" y="652145"/>
            <a:ext cx="2187575" cy="415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en-US" sz="11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Denaturing and reducing SDS-PAGE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Text Box 20">
            <a:extLst>
              <a:ext uri="{FF2B5EF4-FFF2-40B4-BE49-F238E27FC236}">
                <a16:creationId xmlns:a16="http://schemas.microsoft.com/office/drawing/2014/main" id="{6201E253-C6F5-237E-8E6E-0542ED078B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01558" y="6352858"/>
            <a:ext cx="2940050" cy="415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en-US" sz="11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artially denaturing and non-reducing SDS-PAGE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330557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i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05</Words>
  <Application>Microsoft Office PowerPoint</Application>
  <PresentationFormat>A4 (21x29,7 cm)</PresentationFormat>
  <Paragraphs>12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icole Ziliotto</dc:creator>
  <cp:lastModifiedBy>Caricasole Andrea</cp:lastModifiedBy>
  <cp:revision>106</cp:revision>
  <dcterms:created xsi:type="dcterms:W3CDTF">2024-07-26T07:28:45Z</dcterms:created>
  <dcterms:modified xsi:type="dcterms:W3CDTF">2025-02-23T14:19:08Z</dcterms:modified>
</cp:coreProperties>
</file>